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6" d="100"/>
          <a:sy n="116" d="100"/>
        </p:scale>
        <p:origin x="-1000" y="-11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046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359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276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15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523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61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383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14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00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061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056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456B02-685C-4E76-A83D-C1F4D44E54DE}" type="datetimeFigureOut">
              <a:rPr lang="en-US" smtClean="0"/>
              <a:t>9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A43AE2-4D4A-4BAC-8C08-71E852A04715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547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chipseq_dn_noncoding.tif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1066800"/>
            <a:ext cx="3743999" cy="3743999"/>
          </a:xfrm>
          <a:prstGeom prst="rect">
            <a:avLst/>
          </a:prstGeom>
        </p:spPr>
      </p:pic>
      <p:pic>
        <p:nvPicPr>
          <p:cNvPr id="3" name="Immagine 2" descr="chipseq_up_noncoding.tiff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400" y="914400"/>
            <a:ext cx="3743986" cy="3743986"/>
          </a:xfrm>
          <a:prstGeom prst="rect">
            <a:avLst/>
          </a:prstGeom>
        </p:spPr>
      </p:pic>
      <p:sp>
        <p:nvSpPr>
          <p:cNvPr id="9" name="CasellaDiTesto 2"/>
          <p:cNvSpPr txBox="1"/>
          <p:nvPr/>
        </p:nvSpPr>
        <p:spPr>
          <a:xfrm>
            <a:off x="7129579" y="6565540"/>
            <a:ext cx="2776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Helvetica"/>
                <a:cs typeface="Helvetica"/>
              </a:rPr>
              <a:t>Supplementary information, Figure </a:t>
            </a:r>
            <a:r>
              <a:rPr lang="en-GB" sz="1200" dirty="0" smtClean="0">
                <a:latin typeface="Helvetica"/>
                <a:cs typeface="Helvetica"/>
              </a:rPr>
              <a:t>S3</a:t>
            </a:r>
            <a:endParaRPr lang="en-GB" sz="1200" dirty="0">
              <a:latin typeface="Helvetica"/>
              <a:cs typeface="Helvetica"/>
            </a:endParaRPr>
          </a:p>
        </p:txBody>
      </p:sp>
      <p:sp>
        <p:nvSpPr>
          <p:cNvPr id="2" name="CasellaDiTesto 1"/>
          <p:cNvSpPr txBox="1"/>
          <p:nvPr/>
        </p:nvSpPr>
        <p:spPr>
          <a:xfrm>
            <a:off x="3526020" y="1018401"/>
            <a:ext cx="147588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/>
                <a:cs typeface="Helvetica"/>
              </a:rPr>
              <a:t>ChIP-seq_CEBPD</a:t>
            </a:r>
            <a:endParaRPr lang="en-GB" sz="1200" dirty="0">
              <a:latin typeface="Helvetica"/>
              <a:cs typeface="Helvetica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8316210" y="866001"/>
            <a:ext cx="147588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/>
                <a:cs typeface="Helvetica"/>
              </a:rPr>
              <a:t>ChIP-seq_CEBPD</a:t>
            </a:r>
            <a:endParaRPr lang="en-GB" sz="1200" dirty="0">
              <a:latin typeface="Helvetica"/>
              <a:cs typeface="Helvetica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33955" y="1665989"/>
            <a:ext cx="147588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/>
                <a:cs typeface="Helvetica"/>
              </a:rPr>
              <a:t>ChIP-seq_CEBPB</a:t>
            </a:r>
            <a:endParaRPr lang="en-GB" sz="1200" dirty="0">
              <a:latin typeface="Helvetica"/>
              <a:cs typeface="Helvetica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4797270" y="1516912"/>
            <a:ext cx="147588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/>
                <a:cs typeface="Helvetica"/>
              </a:rPr>
              <a:t>ChIP-seq_CEBPB</a:t>
            </a:r>
            <a:endParaRPr lang="en-GB" sz="1200" dirty="0">
              <a:latin typeface="Helvetica"/>
              <a:cs typeface="Helvetica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7010400" y="4495800"/>
            <a:ext cx="170724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/>
                <a:cs typeface="Helvetica"/>
              </a:rPr>
              <a:t>Upregulated_lncRNAs</a:t>
            </a:r>
            <a:endParaRPr lang="en-GB" sz="1200" dirty="0">
              <a:latin typeface="Helvetica"/>
              <a:cs typeface="Helvetica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2438400" y="4648200"/>
            <a:ext cx="190396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200" dirty="0" err="1" smtClean="0">
                <a:latin typeface="Helvetica"/>
                <a:cs typeface="Helvetica"/>
              </a:rPr>
              <a:t>Downregulated_lncRNAs</a:t>
            </a:r>
            <a:endParaRPr lang="en-GB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544830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19</Words>
  <Application>Microsoft Macintosh PowerPoint</Application>
  <PresentationFormat>A4 (21x29,7 cm)</PresentationFormat>
  <Paragraphs>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Presentazione di PowerPoint</vt:lpstr>
    </vt:vector>
  </TitlesOfParts>
  <Company>Columbia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derico M. Giorgi</dc:creator>
  <cp:lastModifiedBy>Dilbert</cp:lastModifiedBy>
  <cp:revision>10</cp:revision>
  <dcterms:created xsi:type="dcterms:W3CDTF">2014-06-29T00:41:13Z</dcterms:created>
  <dcterms:modified xsi:type="dcterms:W3CDTF">2014-09-12T12:36:22Z</dcterms:modified>
</cp:coreProperties>
</file>